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6093D-9ABA-4184-B2D8-C3DB8F4B89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4873C-B9A5-4A35-B170-16EF26B4A3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4276F-95DE-4712-8F85-4E42808E94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C01477-9B7F-4EE5-94D9-7AC0F3A560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DD89F-1D02-46C4-86DC-B4A2343CA8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AEE28-5974-46E1-91FA-465A8F59A9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32B88-D55E-486E-9B25-201D4A443D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98A062-FDA6-45E3-B331-2FE2672C1C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F304B-E817-4E00-849E-6953AAE612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9548C-2A7A-49DF-887B-64640CC49A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961BC-6FF9-493C-BB3A-FD47C733BC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B24BD-2D5D-4729-A58E-83DEF44ABF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4D5CAD2-7441-41D5-8E9E-D63FD7D3385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677880" y="285840"/>
            <a:ext cx="7778880" cy="87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Myriad Pro Semibold"/>
                <a:ea typeface="ＭＳ Ｐゴシック"/>
              </a:rPr>
              <a:t>Figure S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Myriad Pro Semibold"/>
                <a:ea typeface="ＭＳ Ｐゴシック"/>
              </a:rPr>
              <a:t>Modulation of NMDA antagonist increases in extracellular glutamate in CA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rcRect l="4477" t="26373" r="52925" b="17357"/>
          <a:stretch/>
        </p:blipFill>
        <p:spPr>
          <a:xfrm>
            <a:off x="133200" y="2355840"/>
            <a:ext cx="4011840" cy="2556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4268880" y="2705040"/>
            <a:ext cx="4616280" cy="2113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" descr=""/>
          <p:cNvPicPr/>
          <p:nvPr/>
        </p:nvPicPr>
        <p:blipFill>
          <a:blip r:embed="rId3"/>
          <a:srcRect l="4089" t="9021" r="4775" b="5648"/>
          <a:stretch/>
        </p:blipFill>
        <p:spPr>
          <a:xfrm>
            <a:off x="5884920" y="4991040"/>
            <a:ext cx="2155680" cy="109872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6"/>
          <p:cNvSpPr/>
          <p:nvPr/>
        </p:nvSpPr>
        <p:spPr>
          <a:xfrm>
            <a:off x="5054760" y="6103800"/>
            <a:ext cx="400032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dapted from Schobel, Moore, Small et a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6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nodeType="withEffect" fill="hold" presetClass="entr" presetID="168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8-08T15:52:37Z</dcterms:created>
  <dc:creator>Delgado, Iris (NYSPI)</dc:creator>
  <dc:description/>
  <dc:language>en-US</dc:language>
  <cp:lastModifiedBy>Nishanth Kumar KH.</cp:lastModifiedBy>
  <dcterms:modified xsi:type="dcterms:W3CDTF">2017-12-28T12:24:50Z</dcterms:modified>
  <cp:revision>2</cp:revision>
  <dc:subject/>
  <dc:title>PowerPoint Presentation</dc:title>
</cp:coreProperties>
</file>